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9" autoAdjust="0"/>
    <p:restoredTop sz="94660"/>
  </p:normalViewPr>
  <p:slideViewPr>
    <p:cSldViewPr snapToGrid="0">
      <p:cViewPr varScale="1">
        <p:scale>
          <a:sx n="62" d="100"/>
          <a:sy n="62" d="100"/>
        </p:scale>
        <p:origin x="186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988E8-72A4-4D9C-9F0B-E21AAAA8C2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D2691A-24D7-F434-FA41-7EBA4ED3CE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7C4829-46A2-3EA6-20D2-352D54A26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97659D-8929-65F7-9721-27B99761B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72CEE7-0415-8D75-2DA1-1A77A5F0E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822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75968A-8A1C-CACD-8EDB-4BBF4A38E1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E86E27-736B-7CE2-1D79-8DECF4F36D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15B4D-83CA-1EDC-50FC-240E05781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2F4EC8-EFF6-DA5E-4B87-FE316A3E4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769F36-5860-ACF0-8883-8E98EF460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931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EE5390-58A7-ED6A-D841-1ADD1C33AB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BEC6B1-006E-5D2B-DF97-2D9DAC9DCD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FA278C-10E6-6E54-76D5-9BC840567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8B43B0-9573-F8FB-9E6C-79B5A1FBD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3385B2-8171-929A-EBE0-7CEDBA9DF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435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6AF7C2-4B86-E5B6-A390-D2FEBFBDD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79FF1-4A7F-6059-FF2F-38ED163F58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366E02-93C1-F3A4-17DF-0E5AFAA1C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3C9276-48F9-4275-2E9B-A589C8C80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74CDEB-1CCF-4AC9-FEE7-1E7B211CB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983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4E2A95-D522-C13E-3002-BFEDBEC64E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9A9629-64EE-A1D9-1991-63706A8987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D92438-4074-628B-AE33-BAD46F47E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62167-7273-23DB-BF4D-DA492486C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F57F6F-CA91-4DA9-A2D8-1994CC2EC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864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077939-A8FB-E546-1ECB-5276C080AF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62E298-9136-382B-F256-BBF8AD4C1A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627225-0341-36D9-21DE-6362A15481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7C6E4A-BF34-EA8C-22C4-EF865F020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1D242F-753A-E849-CDB4-ABB054DC3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6241E1-43C2-8940-8BDC-4832549C4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718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31B80-F63F-7E42-1107-DCF9DE7A7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D4181A-A80B-5D32-EC1F-B55B3715C7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48DC65-4AA3-5744-0E2A-0D597ACE66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C21502-817C-4155-A72A-5EEB4939AD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5E8078C-52D5-89CC-0A76-CEF31CEC07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BA4F53-CE16-102F-1774-8ED3736931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ED9438-D3A8-CAA5-B0B3-91E595A89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8BDC49-EB18-0CA9-9D30-852B58E56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167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9E609D-94A3-6910-A21A-674819ECE4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666AA18-DCB1-026B-6CEE-469ECE35A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63301DC-1EC9-A3CA-28B0-9BCF55C73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23E5127-5A2F-E3D0-EAB0-356ED3EA5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091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7F2098-F4E5-E4B4-D612-18EFDE7C3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A8B105-E7B4-83C0-C445-39F88D7BF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622317-90A7-7BE7-7214-FEF189183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497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ED98E6-AD2A-AB8C-CFBE-49C9E41668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5F95E3-5B04-9902-FDAA-D09C3C05A3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364009-6D50-EE10-E037-97C617F525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59E95A-7F8E-10C4-16B8-100D5DFE8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4FBD4A-A736-5CC0-6E61-0109046C89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9718C2-9A7A-A32F-3B08-97AB43598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257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0C4BE5-C1D7-750F-FAC5-24E4498C5C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803E832-66EF-2D48-82F9-DE8186D013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661ECD-E9BD-7ECB-0C10-51B123A55F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C3BD94-BFB9-272A-6014-3D49FE53A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E94AC1-78F0-35B0-1C55-E9CEAC44F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61D721-B6FE-EFBB-9FBB-DDD2B63AC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850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C61BD0-9447-AAEF-9FBD-F5CB8DDEB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18148C-DF61-4DB3-B583-1273AF9E7D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732A41-28DD-44F3-CD38-0AF15058BC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6B4F4-8C6D-44D8-B303-000A3BD760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DBA816-DD36-9758-66E5-3D3BB12B00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A42028-995A-C86F-C807-B8722E55E5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47C4D9-EED1-492A-B2BE-6999A1847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111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61321072-8359-26F5-5CDE-DD3E30B59058}"/>
              </a:ext>
            </a:extLst>
          </p:cNvPr>
          <p:cNvCxnSpPr>
            <a:cxnSpLocks/>
          </p:cNvCxnSpPr>
          <p:nvPr/>
        </p:nvCxnSpPr>
        <p:spPr>
          <a:xfrm>
            <a:off x="5560245" y="2916364"/>
            <a:ext cx="0" cy="37195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" name="Group 30">
            <a:extLst>
              <a:ext uri="{FF2B5EF4-FFF2-40B4-BE49-F238E27FC236}">
                <a16:creationId xmlns:a16="http://schemas.microsoft.com/office/drawing/2014/main" id="{E5D9139D-3AAC-7A37-15CC-DCC14D224BA0}"/>
              </a:ext>
            </a:extLst>
          </p:cNvPr>
          <p:cNvGrpSpPr/>
          <p:nvPr/>
        </p:nvGrpSpPr>
        <p:grpSpPr>
          <a:xfrm>
            <a:off x="0" y="1664814"/>
            <a:ext cx="8656328" cy="2503100"/>
            <a:chOff x="-30993" y="1629957"/>
            <a:chExt cx="8656328" cy="2503100"/>
          </a:xfrm>
        </p:grpSpPr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9E6A82BC-5ABB-EFC8-8562-A37B064D4910}"/>
                </a:ext>
              </a:extLst>
            </p:cNvPr>
            <p:cNvCxnSpPr>
              <a:cxnSpLocks/>
            </p:cNvCxnSpPr>
            <p:nvPr/>
          </p:nvCxnSpPr>
          <p:spPr>
            <a:xfrm>
              <a:off x="619931" y="2835134"/>
              <a:ext cx="0" cy="41951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F694040-9D4A-CBD2-E7D2-04F2B2BA8C59}"/>
                </a:ext>
              </a:extLst>
            </p:cNvPr>
            <p:cNvSpPr txBox="1"/>
            <p:nvPr/>
          </p:nvSpPr>
          <p:spPr>
            <a:xfrm>
              <a:off x="-30993" y="3254645"/>
              <a:ext cx="13173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Birth</a:t>
              </a: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688A3CD4-67D2-34D1-448F-A8B62BEC2AA5}"/>
                </a:ext>
              </a:extLst>
            </p:cNvPr>
            <p:cNvCxnSpPr>
              <a:cxnSpLocks/>
            </p:cNvCxnSpPr>
            <p:nvPr/>
          </p:nvCxnSpPr>
          <p:spPr>
            <a:xfrm>
              <a:off x="3351782" y="2528276"/>
              <a:ext cx="0" cy="4003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30E9C5F-359D-0B11-9060-017936B8324E}"/>
                </a:ext>
              </a:extLst>
            </p:cNvPr>
            <p:cNvSpPr txBox="1"/>
            <p:nvPr/>
          </p:nvSpPr>
          <p:spPr>
            <a:xfrm>
              <a:off x="1134935" y="1629957"/>
              <a:ext cx="229826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dirty="0"/>
                <a:t>3 months of age,</a:t>
              </a:r>
            </a:p>
            <a:p>
              <a:pPr algn="r"/>
              <a:r>
                <a:rPr lang="en-US" dirty="0"/>
                <a:t> day 0 of experiment;</a:t>
              </a:r>
            </a:p>
            <a:p>
              <a:pPr algn="r"/>
              <a:r>
                <a:rPr lang="en-US" dirty="0"/>
                <a:t>PBS injection</a:t>
              </a:r>
            </a:p>
          </p:txBody>
        </p: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50C3C64B-9A5B-2CF2-E5A1-1430D6596EEC}"/>
                </a:ext>
              </a:extLst>
            </p:cNvPr>
            <p:cNvGrpSpPr/>
            <p:nvPr/>
          </p:nvGrpSpPr>
          <p:grpSpPr>
            <a:xfrm>
              <a:off x="1958119" y="2987610"/>
              <a:ext cx="1872706" cy="1016866"/>
              <a:chOff x="398591" y="2939519"/>
              <a:chExt cx="1872706" cy="1016866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7C95E082-3433-6E00-2A92-09D6B86F10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95593" y="2939519"/>
                <a:ext cx="0" cy="3719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FA200AC7-43EA-3C51-6060-CA97EC53926F}"/>
                  </a:ext>
                </a:extLst>
              </p:cNvPr>
              <p:cNvSpPr txBox="1"/>
              <p:nvPr/>
            </p:nvSpPr>
            <p:spPr>
              <a:xfrm>
                <a:off x="398591" y="3310054"/>
                <a:ext cx="18727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dirty="0"/>
                  <a:t>Day 14; </a:t>
                </a:r>
              </a:p>
              <a:p>
                <a:pPr algn="r"/>
                <a:r>
                  <a:rPr lang="en-US" dirty="0"/>
                  <a:t>PBS injection</a:t>
                </a: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A71AF9A5-A945-6676-DAED-B65B97236367}"/>
                </a:ext>
              </a:extLst>
            </p:cNvPr>
            <p:cNvGrpSpPr/>
            <p:nvPr/>
          </p:nvGrpSpPr>
          <p:grpSpPr>
            <a:xfrm>
              <a:off x="3501774" y="1823658"/>
              <a:ext cx="1544105" cy="1090569"/>
              <a:chOff x="1672615" y="1830866"/>
              <a:chExt cx="1544105" cy="1090569"/>
            </a:xfrm>
          </p:grpSpPr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CEC68C8D-423E-B7E5-A7B5-5618B4B96F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25483" y="2549476"/>
                <a:ext cx="0" cy="3719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D47E3FC-7AC8-DCC7-87C6-526AB97F7C4D}"/>
                  </a:ext>
                </a:extLst>
              </p:cNvPr>
              <p:cNvSpPr txBox="1"/>
              <p:nvPr/>
            </p:nvSpPr>
            <p:spPr>
              <a:xfrm>
                <a:off x="1672615" y="1830866"/>
                <a:ext cx="154410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day 28;</a:t>
                </a:r>
              </a:p>
              <a:p>
                <a:pPr algn="ctr"/>
                <a:r>
                  <a:rPr lang="en-US" dirty="0"/>
                  <a:t>PBS injection</a:t>
                </a:r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C8FD2C7F-08E2-B983-66A9-EC92AF1FB3F5}"/>
                </a:ext>
              </a:extLst>
            </p:cNvPr>
            <p:cNvGrpSpPr/>
            <p:nvPr/>
          </p:nvGrpSpPr>
          <p:grpSpPr>
            <a:xfrm>
              <a:off x="3746707" y="2959909"/>
              <a:ext cx="1506189" cy="1123481"/>
              <a:chOff x="1929125" y="2995796"/>
              <a:chExt cx="1506189" cy="1123481"/>
            </a:xfrm>
          </p:grpSpPr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08AA2BBA-79A8-0E17-8ECE-0D5CB67EB9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29001" y="2995796"/>
                <a:ext cx="0" cy="3719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64C173AE-3735-65F7-A39C-EB821661E25B}"/>
                  </a:ext>
                </a:extLst>
              </p:cNvPr>
              <p:cNvSpPr txBox="1"/>
              <p:nvPr/>
            </p:nvSpPr>
            <p:spPr>
              <a:xfrm>
                <a:off x="1929125" y="3472946"/>
                <a:ext cx="150618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dirty="0"/>
                  <a:t>Day 56; </a:t>
                </a:r>
              </a:p>
              <a:p>
                <a:pPr algn="r"/>
                <a:r>
                  <a:rPr lang="en-US" dirty="0"/>
                  <a:t>PBS injection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21860C68-BF8A-123B-CE1B-ABBD2E14321F}"/>
                </a:ext>
              </a:extLst>
            </p:cNvPr>
            <p:cNvGrpSpPr/>
            <p:nvPr/>
          </p:nvGrpSpPr>
          <p:grpSpPr>
            <a:xfrm>
              <a:off x="5368124" y="1872174"/>
              <a:ext cx="1506189" cy="1033453"/>
              <a:chOff x="3530545" y="1833563"/>
              <a:chExt cx="1506189" cy="1033453"/>
            </a:xfrm>
          </p:grpSpPr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48B05CE8-05CE-F4F4-7CBA-CE831D74504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848" y="2495057"/>
                <a:ext cx="0" cy="3719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A2D79A8-DBE7-668B-C337-1A464634E337}"/>
                  </a:ext>
                </a:extLst>
              </p:cNvPr>
              <p:cNvSpPr txBox="1"/>
              <p:nvPr/>
            </p:nvSpPr>
            <p:spPr>
              <a:xfrm>
                <a:off x="3530545" y="1833563"/>
                <a:ext cx="150618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Day 84; </a:t>
                </a:r>
              </a:p>
              <a:p>
                <a:pPr algn="ctr"/>
                <a:r>
                  <a:rPr lang="en-US" dirty="0"/>
                  <a:t>PBS injection</a:t>
                </a: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EED2CF67-104A-E109-9833-7A42E2E017A0}"/>
                </a:ext>
              </a:extLst>
            </p:cNvPr>
            <p:cNvGrpSpPr/>
            <p:nvPr/>
          </p:nvGrpSpPr>
          <p:grpSpPr>
            <a:xfrm>
              <a:off x="6898033" y="1806956"/>
              <a:ext cx="1506189" cy="1007850"/>
              <a:chOff x="5088898" y="2321812"/>
              <a:chExt cx="1506189" cy="1007850"/>
            </a:xfrm>
          </p:grpSpPr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930EFD65-D8E7-6FE4-A151-E0AA9F67FA4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68696" y="2957703"/>
                <a:ext cx="0" cy="3719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8A066FD-CAE8-776C-2254-53805A1F3915}"/>
                  </a:ext>
                </a:extLst>
              </p:cNvPr>
              <p:cNvSpPr txBox="1"/>
              <p:nvPr/>
            </p:nvSpPr>
            <p:spPr>
              <a:xfrm>
                <a:off x="5088898" y="2321812"/>
                <a:ext cx="150618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Day 112; </a:t>
                </a:r>
              </a:p>
              <a:p>
                <a:r>
                  <a:rPr lang="en-US" dirty="0"/>
                  <a:t>end</a:t>
                </a:r>
              </a:p>
            </p:txBody>
          </p:sp>
        </p:grpSp>
        <p:sp>
          <p:nvSpPr>
            <p:cNvPr id="29" name="Right Brace 28">
              <a:extLst>
                <a:ext uri="{FF2B5EF4-FFF2-40B4-BE49-F238E27FC236}">
                  <a16:creationId xmlns:a16="http://schemas.microsoft.com/office/drawing/2014/main" id="{21C5F308-C9BA-D1FA-E2BD-7C67BAE2A87F}"/>
                </a:ext>
              </a:extLst>
            </p:cNvPr>
            <p:cNvSpPr/>
            <p:nvPr/>
          </p:nvSpPr>
          <p:spPr>
            <a:xfrm rot="5400000">
              <a:off x="6306063" y="2794017"/>
              <a:ext cx="450501" cy="889775"/>
            </a:xfrm>
            <a:prstGeom prst="rightBrace">
              <a:avLst>
                <a:gd name="adj1" fmla="val 8333"/>
                <a:gd name="adj2" fmla="val 48316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2AE5E79-A3D3-86DD-AC79-99A5DF388C7F}"/>
                </a:ext>
              </a:extLst>
            </p:cNvPr>
            <p:cNvSpPr txBox="1"/>
            <p:nvPr/>
          </p:nvSpPr>
          <p:spPr>
            <a:xfrm flipH="1">
              <a:off x="6315533" y="3486726"/>
              <a:ext cx="230980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Behavioral acclimation and testing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2E7A42FE-F827-7870-ED55-46ABCF806C9A}"/>
                </a:ext>
              </a:extLst>
            </p:cNvPr>
            <p:cNvSpPr/>
            <p:nvPr/>
          </p:nvSpPr>
          <p:spPr>
            <a:xfrm>
              <a:off x="623455" y="2834785"/>
              <a:ext cx="6352746" cy="1633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3DAE2A16-24DE-D2F2-AAFF-EE048A0BB07E}"/>
              </a:ext>
            </a:extLst>
          </p:cNvPr>
          <p:cNvSpPr txBox="1"/>
          <p:nvPr/>
        </p:nvSpPr>
        <p:spPr>
          <a:xfrm>
            <a:off x="4731859" y="3377186"/>
            <a:ext cx="15061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Day 70</a:t>
            </a:r>
          </a:p>
          <a:p>
            <a:pPr algn="r"/>
            <a:r>
              <a:rPr lang="en-US" dirty="0"/>
              <a:t>Tail bleed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9D845A24-3C15-59E3-E1BC-FB2C9728247A}"/>
              </a:ext>
            </a:extLst>
          </p:cNvPr>
          <p:cNvSpPr/>
          <p:nvPr/>
        </p:nvSpPr>
        <p:spPr>
          <a:xfrm>
            <a:off x="6096000" y="2873370"/>
            <a:ext cx="908805" cy="16344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ight Brace 43">
            <a:extLst>
              <a:ext uri="{FF2B5EF4-FFF2-40B4-BE49-F238E27FC236}">
                <a16:creationId xmlns:a16="http://schemas.microsoft.com/office/drawing/2014/main" id="{DFAE239E-9460-28AA-F2D8-8575A462B499}"/>
              </a:ext>
            </a:extLst>
          </p:cNvPr>
          <p:cNvSpPr/>
          <p:nvPr/>
        </p:nvSpPr>
        <p:spPr>
          <a:xfrm rot="16200000">
            <a:off x="8565164" y="2482889"/>
            <a:ext cx="535982" cy="3766957"/>
          </a:xfrm>
          <a:prstGeom prst="rightBrace">
            <a:avLst>
              <a:gd name="adj1" fmla="val 8333"/>
              <a:gd name="adj2" fmla="val 20604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2628CDEA-3EAB-6E9C-4BB1-E371D901255C}"/>
              </a:ext>
            </a:extLst>
          </p:cNvPr>
          <p:cNvCxnSpPr>
            <a:cxnSpLocks/>
          </p:cNvCxnSpPr>
          <p:nvPr/>
        </p:nvCxnSpPr>
        <p:spPr>
          <a:xfrm>
            <a:off x="10663382" y="5256510"/>
            <a:ext cx="0" cy="37195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47F0141C-90DB-6B37-5A1F-C41E89FF8094}"/>
              </a:ext>
            </a:extLst>
          </p:cNvPr>
          <p:cNvSpPr txBox="1"/>
          <p:nvPr/>
        </p:nvSpPr>
        <p:spPr>
          <a:xfrm>
            <a:off x="10432582" y="4620619"/>
            <a:ext cx="15061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y 112; </a:t>
            </a:r>
          </a:p>
          <a:p>
            <a:r>
              <a:rPr lang="en-US" dirty="0"/>
              <a:t>end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0EF89A95-D9DB-E957-B3DD-1C631BCC7726}"/>
              </a:ext>
            </a:extLst>
          </p:cNvPr>
          <p:cNvGrpSpPr/>
          <p:nvPr/>
        </p:nvGrpSpPr>
        <p:grpSpPr>
          <a:xfrm>
            <a:off x="6097129" y="4710326"/>
            <a:ext cx="5078844" cy="2157484"/>
            <a:chOff x="5957007" y="4693783"/>
            <a:chExt cx="5078844" cy="2157484"/>
          </a:xfrm>
        </p:grpSpPr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0100A432-90E0-B97D-3DE6-B0FC10E0F1F5}"/>
                </a:ext>
              </a:extLst>
            </p:cNvPr>
            <p:cNvGrpSpPr/>
            <p:nvPr/>
          </p:nvGrpSpPr>
          <p:grpSpPr>
            <a:xfrm>
              <a:off x="5957007" y="4693783"/>
              <a:ext cx="5078844" cy="2157484"/>
              <a:chOff x="-281041" y="4167548"/>
              <a:chExt cx="5078844" cy="2157484"/>
            </a:xfrm>
          </p:grpSpPr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7305AD9D-450B-F999-2B5E-C08683EE6A4A}"/>
                  </a:ext>
                </a:extLst>
              </p:cNvPr>
              <p:cNvSpPr/>
              <p:nvPr/>
            </p:nvSpPr>
            <p:spPr>
              <a:xfrm>
                <a:off x="650924" y="5066950"/>
                <a:ext cx="3634711" cy="126236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" name="Straight Connector 4">
                <a:extLst>
                  <a:ext uri="{FF2B5EF4-FFF2-40B4-BE49-F238E27FC236}">
                    <a16:creationId xmlns:a16="http://schemas.microsoft.com/office/drawing/2014/main" id="{BA272B7F-81A6-E73C-078F-BDFB7D7F34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4146" y="4845842"/>
                <a:ext cx="0" cy="31066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6D493DD-B51B-F5BC-4604-9CB2A3ABFC54}"/>
                  </a:ext>
                </a:extLst>
              </p:cNvPr>
              <p:cNvSpPr txBox="1"/>
              <p:nvPr/>
            </p:nvSpPr>
            <p:spPr>
              <a:xfrm>
                <a:off x="-281041" y="4235000"/>
                <a:ext cx="186766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Day 84 Transfer and acclimation</a:t>
                </a:r>
              </a:p>
            </p:txBody>
          </p: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90E1B94D-C3B5-2C6A-7C26-4CEF8624EF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24778" y="5191189"/>
                <a:ext cx="0" cy="31066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06F5D45-B2DA-AB09-2272-86EDDA546A0B}"/>
                  </a:ext>
                </a:extLst>
              </p:cNvPr>
              <p:cNvSpPr txBox="1"/>
              <p:nvPr/>
            </p:nvSpPr>
            <p:spPr>
              <a:xfrm>
                <a:off x="866102" y="5384898"/>
                <a:ext cx="131735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Y-maze</a:t>
                </a:r>
              </a:p>
            </p:txBody>
          </p: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0A8DAE0D-B86D-5F75-48C6-032BAE1345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63740" y="4781526"/>
                <a:ext cx="0" cy="31066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CAA99927-EC9D-7C6C-80A3-9A9598A8C73B}"/>
                  </a:ext>
                </a:extLst>
              </p:cNvPr>
              <p:cNvSpPr txBox="1"/>
              <p:nvPr/>
            </p:nvSpPr>
            <p:spPr>
              <a:xfrm>
                <a:off x="866102" y="5381158"/>
                <a:ext cx="131735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Y-maze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E2D9A9C6-1021-A33D-697F-5F5BC2D72AC9}"/>
                  </a:ext>
                </a:extLst>
              </p:cNvPr>
              <p:cNvSpPr txBox="1"/>
              <p:nvPr/>
            </p:nvSpPr>
            <p:spPr>
              <a:xfrm>
                <a:off x="1500416" y="4367442"/>
                <a:ext cx="131735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Open field</a:t>
                </a:r>
              </a:p>
            </p:txBody>
          </p: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B7E0DD1B-BDAB-5FD4-B6EA-B4D6D779F4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60089" y="5093317"/>
                <a:ext cx="0" cy="31066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78CCB020-2299-EC49-6EB7-C15364431844}"/>
                  </a:ext>
                </a:extLst>
              </p:cNvPr>
              <p:cNvSpPr txBox="1"/>
              <p:nvPr/>
            </p:nvSpPr>
            <p:spPr>
              <a:xfrm>
                <a:off x="2015089" y="5401702"/>
                <a:ext cx="1317352" cy="9233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Novel object recognition</a:t>
                </a:r>
              </a:p>
            </p:txBody>
          </p: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5A156A07-44A1-10F3-5615-3F78E58AB0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30541" y="4766146"/>
                <a:ext cx="0" cy="31066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6C190C33-5F4E-F4B6-FE2E-FA6D2117E478}"/>
                  </a:ext>
                </a:extLst>
              </p:cNvPr>
              <p:cNvSpPr txBox="1"/>
              <p:nvPr/>
            </p:nvSpPr>
            <p:spPr>
              <a:xfrm>
                <a:off x="2563476" y="4167548"/>
                <a:ext cx="1317352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Marble burying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80B0F9E2-1E07-D9ED-4166-F591228B30D2}"/>
                  </a:ext>
                </a:extLst>
              </p:cNvPr>
              <p:cNvSpPr txBox="1"/>
              <p:nvPr/>
            </p:nvSpPr>
            <p:spPr>
              <a:xfrm>
                <a:off x="3291614" y="5486990"/>
                <a:ext cx="150618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Conditioned fear (4 days)</a:t>
                </a:r>
              </a:p>
            </p:txBody>
          </p:sp>
        </p:grp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9BAF515D-1D21-0A44-28BA-C7C36DBF4EB5}"/>
                </a:ext>
              </a:extLst>
            </p:cNvPr>
            <p:cNvSpPr/>
            <p:nvPr/>
          </p:nvSpPr>
          <p:spPr>
            <a:xfrm>
              <a:off x="9991289" y="5586524"/>
              <a:ext cx="532399" cy="132897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9" name="Left Brace 48">
            <a:extLst>
              <a:ext uri="{FF2B5EF4-FFF2-40B4-BE49-F238E27FC236}">
                <a16:creationId xmlns:a16="http://schemas.microsoft.com/office/drawing/2014/main" id="{182D2A06-E38C-6A3C-EEA3-C5AF4568E95F}"/>
              </a:ext>
            </a:extLst>
          </p:cNvPr>
          <p:cNvSpPr/>
          <p:nvPr/>
        </p:nvSpPr>
        <p:spPr>
          <a:xfrm rot="16200000">
            <a:off x="10249083" y="5657780"/>
            <a:ext cx="301169" cy="527431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055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00</TotalTime>
  <Words>70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</dc:creator>
  <cp:lastModifiedBy>CO</cp:lastModifiedBy>
  <cp:revision>9</cp:revision>
  <dcterms:created xsi:type="dcterms:W3CDTF">2023-05-15T19:42:28Z</dcterms:created>
  <dcterms:modified xsi:type="dcterms:W3CDTF">2023-05-23T19:46:10Z</dcterms:modified>
</cp:coreProperties>
</file>